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7" r:id="rId2"/>
    <p:sldId id="290" r:id="rId3"/>
    <p:sldId id="281" r:id="rId4"/>
    <p:sldId id="279" r:id="rId5"/>
    <p:sldId id="280" r:id="rId6"/>
    <p:sldId id="288" r:id="rId7"/>
    <p:sldId id="282" r:id="rId8"/>
    <p:sldId id="285" r:id="rId9"/>
    <p:sldId id="283" r:id="rId10"/>
    <p:sldId id="286" r:id="rId11"/>
    <p:sldId id="289" r:id="rId12"/>
    <p:sldId id="287" r:id="rId13"/>
  </p:sldIdLst>
  <p:sldSz cx="12192000" cy="6858000"/>
  <p:notesSz cx="6858000" cy="9144000"/>
  <p:defaultTextStyle>
    <a:defPPr>
      <a:defRPr lang="es-A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0" d="100"/>
          <a:sy n="70" d="100"/>
        </p:scale>
        <p:origin x="738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D917AA9-8B88-44EF-9D30-ADB3675F0D1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CD6035CE-7265-4E84-9BB6-8CAA8ED864D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7E8E19DE-C9CD-4A3B-AC2F-9DDF9E182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7EE4A00-A867-49FA-B741-B99F4AE09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997B058-5ED3-4CA6-A2D2-7C6B69212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9911154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202F15D-522F-48EE-AAB9-2B566662FB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1151870B-D4C3-4032-A2FF-C2223F1168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365398D-F3CB-440C-A185-F98E4F6D24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DB110026-4EAE-4599-BFBB-B368FF4C0C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9AFCC97A-7B5D-4DAB-B9ED-9261577428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1325201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3CF1F6E7-9B50-416E-9B97-8D7A901E46F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8B7C85E7-9CF4-4B19-8E59-CFB8A93F6E3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9197B5B2-C309-4462-978D-7A818D93C5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58918AE1-C3CC-4CF8-89EE-8DCBC343BA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7F9A1EF4-6227-4176-870D-F58A58B529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19807847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72AEB41-2285-4B19-940E-29C68E7FB39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6803C03-5FA2-4BDC-BEF3-B56A0329CE2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F66BB41-7EB2-46B1-84B7-0BCE153A65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C565DBE-C588-4923-BB62-E961684DB6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FE375DE9-16D8-4AD9-B92D-DBAF8F6E18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5167173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8C3F21C9-72A6-4620-9ABD-2E5AE7EFB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4224D659-3A59-44F2-84F5-11533C9FBA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0C92A7A1-7468-493E-9AEF-FA446B39D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618566BE-903E-45F7-8530-900BCF7543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02054B4B-76EF-493E-9456-BE936199AF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39679588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7FDE744-BE50-434F-BB01-AA4061716D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896CC678-1837-446B-A455-AFEB803FD6E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ABF0CD32-DBB3-4202-BA4D-4230CD3765A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4CEC3734-9F6B-4BF8-A876-29E45CF669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56DA339-5123-49B3-9386-9554F9DA92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633B080-6C2C-4FD7-8CDE-7955A470E5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41201697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25C014E8-8512-4923-97E4-1C737E84EA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5CA12779-717D-4D33-BFBA-1BA37FCF829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1C94D7C6-8118-4FFC-B713-118186A43C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38C4637A-76D7-4186-8069-150F6B7579E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83A8C0FA-C79F-429A-AECF-878F761F2C6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BECD9951-0CBC-4D0F-A110-2569B9667F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B60B0750-BF7A-4B81-8D81-55BEAF8FD3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D57CE843-A755-4EAE-AD79-45A315A0A3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244331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CF6DEED9-AA3B-4975-82CC-DDADE7C945B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83635ED5-59C5-4B87-A9F6-5E148A44FE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62EB1E01-599C-4E21-A05D-64DF594FC3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4C3B2045-C415-436B-9CCA-92022DF77F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0205511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DD72DCF3-86B7-4E71-9605-D8296043B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8F98F8AD-A1F2-4EE9-96BE-680962AAC9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65E59D05-6EBA-4BA5-95A3-7615FC4CF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6695763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AB6D8F0-DE2A-452D-9CA1-54FE6751BD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A0C585D1-013B-422D-AF41-0712023B844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5FB7FA3D-1FD0-44A5-A9C5-0566A5ABAE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22CEBB13-072B-412C-AB20-6455139B36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3BE45F8B-F535-40AD-A963-3852539021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230F7420-DDEA-4FFC-8C2C-031315C04E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29980673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4F018DF-CECA-4216-9A82-7865880BCE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F9C2BFAF-0745-438A-BBA1-B4C0130A981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AR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A4CE32AC-21D8-4AAE-A2B1-090E097005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60BC0DCF-B250-4A94-90AB-D1A0FF0AF7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A402E376-2B07-41B8-9C56-E2BAF2894C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AR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6F377311-F1F4-4FFA-9DED-878E99E70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0788971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B2617749-F8C7-474F-A845-1791FE9113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s-AR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D5A056A0-32BB-4187-8963-985B038671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s-AR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10B509C7-EF2C-4A5F-913C-CBF708B901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C63BAC-1F31-4CEC-B614-25DB17BF0B2A}" type="datetimeFigureOut">
              <a:rPr lang="es-AR" smtClean="0"/>
              <a:t>24/11/2021</a:t>
            </a:fld>
            <a:endParaRPr lang="es-AR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3F9B0FB-B4BF-4D0C-BAC8-2FE062E9CBC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AR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11507930-E3A9-44E5-97E6-07F81C18244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B35A0B-9DB2-4729-BA9D-AE8FA74B4A0F}" type="slidenum">
              <a:rPr lang="es-AR" smtClean="0"/>
              <a:t>‹Nº›</a:t>
            </a:fld>
            <a:endParaRPr lang="es-AR"/>
          </a:p>
        </p:txBody>
      </p:sp>
    </p:spTree>
    <p:extLst>
      <p:ext uri="{BB962C8B-B14F-4D97-AF65-F5344CB8AC3E}">
        <p14:creationId xmlns:p14="http://schemas.microsoft.com/office/powerpoint/2010/main" val="18449487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A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0.emf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1.emf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6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7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9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6C983D88-F966-48FD-8250-A2B9EFD88D42}"/>
              </a:ext>
            </a:extLst>
          </p:cNvPr>
          <p:cNvSpPr txBox="1"/>
          <p:nvPr/>
        </p:nvSpPr>
        <p:spPr>
          <a:xfrm>
            <a:off x="2135560" y="2060849"/>
            <a:ext cx="8105104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400" b="1" dirty="0"/>
              <a:t>Nucleus-cytoskeleton communication in embryonic stem cells </a:t>
            </a:r>
          </a:p>
          <a:p>
            <a:pPr algn="ctr"/>
            <a:r>
              <a:rPr lang="en-US" sz="2400" b="1" dirty="0"/>
              <a:t>and its impact on OCT4-chromatin interactions</a:t>
            </a:r>
          </a:p>
        </p:txBody>
      </p:sp>
      <p:sp>
        <p:nvSpPr>
          <p:cNvPr id="3" name="TextBox 3">
            <a:extLst>
              <a:ext uri="{FF2B5EF4-FFF2-40B4-BE49-F238E27FC236}">
                <a16:creationId xmlns:a16="http://schemas.microsoft.com/office/drawing/2014/main" id="{E12950BD-0B75-49B5-8817-ABF5228EB5EA}"/>
              </a:ext>
            </a:extLst>
          </p:cNvPr>
          <p:cNvSpPr txBox="1"/>
          <p:nvPr/>
        </p:nvSpPr>
        <p:spPr>
          <a:xfrm>
            <a:off x="5159897" y="3019751"/>
            <a:ext cx="16433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Romero JJ et al.</a:t>
            </a:r>
          </a:p>
        </p:txBody>
      </p:sp>
      <p:sp>
        <p:nvSpPr>
          <p:cNvPr id="4" name="TextBox 4">
            <a:extLst>
              <a:ext uri="{FF2B5EF4-FFF2-40B4-BE49-F238E27FC236}">
                <a16:creationId xmlns:a16="http://schemas.microsoft.com/office/drawing/2014/main" id="{51982E15-AC6B-4E65-B48C-C02C195A8890}"/>
              </a:ext>
            </a:extLst>
          </p:cNvPr>
          <p:cNvSpPr txBox="1"/>
          <p:nvPr/>
        </p:nvSpPr>
        <p:spPr>
          <a:xfrm>
            <a:off x="2326415" y="4076603"/>
            <a:ext cx="7723396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AR" dirty="0" err="1"/>
              <a:t>Additional</a:t>
            </a:r>
            <a:r>
              <a:rPr lang="es-AR" dirty="0"/>
              <a:t> file 14 – </a:t>
            </a:r>
            <a:r>
              <a:rPr lang="es-AR" dirty="0" err="1"/>
              <a:t>Supplementary</a:t>
            </a:r>
            <a:r>
              <a:rPr lang="es-AR" dirty="0"/>
              <a:t> Fig. S6</a:t>
            </a:r>
          </a:p>
          <a:p>
            <a:pPr algn="ctr"/>
            <a:endParaRPr lang="es-AR" dirty="0"/>
          </a:p>
          <a:p>
            <a:pPr algn="ctr"/>
            <a:endParaRPr lang="es-AR" dirty="0"/>
          </a:p>
          <a:p>
            <a:pPr algn="ctr"/>
            <a:r>
              <a:rPr lang="en-US" dirty="0"/>
              <a:t>Representative 3D images of ES cells expressing EMTB-3xGFP  and H2B-mCherry </a:t>
            </a:r>
          </a:p>
        </p:txBody>
      </p:sp>
      <p:sp>
        <p:nvSpPr>
          <p:cNvPr id="6" name="Rectangle 8">
            <a:extLst>
              <a:ext uri="{FF2B5EF4-FFF2-40B4-BE49-F238E27FC236}">
                <a16:creationId xmlns:a16="http://schemas.microsoft.com/office/drawing/2014/main" id="{92066D0E-B857-44A0-88DE-41E0EA60CE5D}"/>
              </a:ext>
            </a:extLst>
          </p:cNvPr>
          <p:cNvSpPr/>
          <p:nvPr/>
        </p:nvSpPr>
        <p:spPr>
          <a:xfrm>
            <a:off x="78689" y="6573470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9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827008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8">
            <a:extLst>
              <a:ext uri="{FF2B5EF4-FFF2-40B4-BE49-F238E27FC236}">
                <a16:creationId xmlns:a16="http://schemas.microsoft.com/office/drawing/2014/main" id="{70BB75A1-3FCB-4E88-B833-BBA6C19DABE9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2" descr="Resultado de imagen para iquibicen conicet">
            <a:extLst>
              <a:ext uri="{FF2B5EF4-FFF2-40B4-BE49-F238E27FC236}">
                <a16:creationId xmlns:a16="http://schemas.microsoft.com/office/drawing/2014/main" id="{BF791A64-315F-4CBE-B290-96AD662DF0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Resultado de imagen para quimica biologica uba logo">
            <a:extLst>
              <a:ext uri="{FF2B5EF4-FFF2-40B4-BE49-F238E27FC236}">
                <a16:creationId xmlns:a16="http://schemas.microsoft.com/office/drawing/2014/main" id="{D8DB804E-5A53-4695-A0FB-0083D261717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7">
            <a:extLst>
              <a:ext uri="{FF2B5EF4-FFF2-40B4-BE49-F238E27FC236}">
                <a16:creationId xmlns:a16="http://schemas.microsoft.com/office/drawing/2014/main" id="{A0ED54F8-F2FF-49EF-9DF7-6AA9C22555B0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7DB84CDF-45CB-4D4D-ABF0-8D6F38ABE5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81297" y="1213104"/>
            <a:ext cx="9884547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036297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8">
            <a:extLst>
              <a:ext uri="{FF2B5EF4-FFF2-40B4-BE49-F238E27FC236}">
                <a16:creationId xmlns:a16="http://schemas.microsoft.com/office/drawing/2014/main" id="{36B7FF51-A6CB-4D40-B6EA-E34F2505ED85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2" descr="Resultado de imagen para iquibicen conicet">
            <a:extLst>
              <a:ext uri="{FF2B5EF4-FFF2-40B4-BE49-F238E27FC236}">
                <a16:creationId xmlns:a16="http://schemas.microsoft.com/office/drawing/2014/main" id="{AC2CE825-A165-4227-8994-7634D5C2CB1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Resultado de imagen para quimica biologica uba logo">
            <a:extLst>
              <a:ext uri="{FF2B5EF4-FFF2-40B4-BE49-F238E27FC236}">
                <a16:creationId xmlns:a16="http://schemas.microsoft.com/office/drawing/2014/main" id="{C2FAB262-FACC-43A4-B29D-53FA7D2AAD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7">
            <a:extLst>
              <a:ext uri="{FF2B5EF4-FFF2-40B4-BE49-F238E27FC236}">
                <a16:creationId xmlns:a16="http://schemas.microsoft.com/office/drawing/2014/main" id="{BF78E68F-6412-49EE-8CAE-F3227F1E8D2A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5E670D26-4976-44A9-BEBC-C72C0F6CE62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08193" y="1075709"/>
            <a:ext cx="9485519" cy="522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310971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Rectangle 8">
            <a:extLst>
              <a:ext uri="{FF2B5EF4-FFF2-40B4-BE49-F238E27FC236}">
                <a16:creationId xmlns:a16="http://schemas.microsoft.com/office/drawing/2014/main" id="{95CB2AFD-02A8-41E1-81E8-6A85A8C89025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4" name="Picture 2" descr="Resultado de imagen para iquibicen conicet">
            <a:extLst>
              <a:ext uri="{FF2B5EF4-FFF2-40B4-BE49-F238E27FC236}">
                <a16:creationId xmlns:a16="http://schemas.microsoft.com/office/drawing/2014/main" id="{3A78602A-5374-4E0B-9ABB-E7FA2F1C5F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5" name="Picture 4" descr="Resultado de imagen para quimica biologica uba logo">
            <a:extLst>
              <a:ext uri="{FF2B5EF4-FFF2-40B4-BE49-F238E27FC236}">
                <a16:creationId xmlns:a16="http://schemas.microsoft.com/office/drawing/2014/main" id="{B3FD0663-BB44-4CB3-807F-619EF8F90DF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6" name="Rectangle 7">
            <a:extLst>
              <a:ext uri="{FF2B5EF4-FFF2-40B4-BE49-F238E27FC236}">
                <a16:creationId xmlns:a16="http://schemas.microsoft.com/office/drawing/2014/main" id="{EBCD8444-3D3D-467A-8B94-DF1F245A6B60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A4DAC5B7-F5D0-4210-98E2-FB7B41D5AD6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40787" y="1093439"/>
            <a:ext cx="9520947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9753502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2">
            <a:extLst>
              <a:ext uri="{FF2B5EF4-FFF2-40B4-BE49-F238E27FC236}">
                <a16:creationId xmlns:a16="http://schemas.microsoft.com/office/drawing/2014/main" id="{385E62BD-5716-4FCA-A9D2-C3D8D3A3230F}"/>
              </a:ext>
            </a:extLst>
          </p:cNvPr>
          <p:cNvSpPr txBox="1"/>
          <p:nvPr/>
        </p:nvSpPr>
        <p:spPr>
          <a:xfrm>
            <a:off x="1789043" y="1859340"/>
            <a:ext cx="8825948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800" b="1" dirty="0"/>
              <a:t>W4 ES cell line</a:t>
            </a:r>
            <a:endParaRPr lang="es-AR" sz="4800" b="1" dirty="0"/>
          </a:p>
          <a:p>
            <a:pPr algn="ctr"/>
            <a:endParaRPr lang="es-AR" sz="3200" dirty="0"/>
          </a:p>
          <a:p>
            <a:pPr algn="ctr"/>
            <a:r>
              <a:rPr lang="es-AR" sz="3200" dirty="0" err="1"/>
              <a:t>Transfection</a:t>
            </a:r>
            <a:r>
              <a:rPr lang="es-AR" sz="3200" dirty="0"/>
              <a:t> </a:t>
            </a:r>
            <a:r>
              <a:rPr lang="es-AR" sz="3200" dirty="0" err="1"/>
              <a:t>of</a:t>
            </a:r>
            <a:r>
              <a:rPr lang="es-AR" sz="3200" dirty="0"/>
              <a:t> EMTB-3x</a:t>
            </a:r>
            <a:r>
              <a:rPr lang="es-AR" sz="3200" dirty="0">
                <a:solidFill>
                  <a:schemeClr val="accent6"/>
                </a:solidFill>
              </a:rPr>
              <a:t>GFP</a:t>
            </a:r>
            <a:r>
              <a:rPr lang="es-AR" sz="3200" dirty="0"/>
              <a:t> and H2B-</a:t>
            </a:r>
            <a:r>
              <a:rPr lang="es-AR" sz="3200" dirty="0">
                <a:solidFill>
                  <a:srgbClr val="FF0000"/>
                </a:solidFill>
              </a:rPr>
              <a:t>mCherry</a:t>
            </a:r>
            <a:endParaRPr lang="en-US" sz="3200" dirty="0">
              <a:solidFill>
                <a:srgbClr val="FF0000"/>
              </a:solidFill>
            </a:endParaRPr>
          </a:p>
          <a:p>
            <a:pPr algn="ctr"/>
            <a:endParaRPr lang="en-US" sz="4800" b="1" dirty="0"/>
          </a:p>
        </p:txBody>
      </p:sp>
      <p:sp>
        <p:nvSpPr>
          <p:cNvPr id="3" name="Rectangle 8">
            <a:extLst>
              <a:ext uri="{FF2B5EF4-FFF2-40B4-BE49-F238E27FC236}">
                <a16:creationId xmlns:a16="http://schemas.microsoft.com/office/drawing/2014/main" id="{A3E4B4C6-C7AA-47A8-873B-048887A78985}"/>
              </a:ext>
            </a:extLst>
          </p:cNvPr>
          <p:cNvSpPr/>
          <p:nvPr/>
        </p:nvSpPr>
        <p:spPr>
          <a:xfrm>
            <a:off x="78689" y="6573470"/>
            <a:ext cx="12060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Picture 2" descr="Resultado de imagen para iquibicen conicet">
            <a:extLst>
              <a:ext uri="{FF2B5EF4-FFF2-40B4-BE49-F238E27FC236}">
                <a16:creationId xmlns:a16="http://schemas.microsoft.com/office/drawing/2014/main" id="{FC1307AB-ECED-44A1-9B40-0FB66F01607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105" y="37666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Picture 4" descr="Resultado de imagen para quimica biologica uba logo">
            <a:extLst>
              <a:ext uri="{FF2B5EF4-FFF2-40B4-BE49-F238E27FC236}">
                <a16:creationId xmlns:a16="http://schemas.microsoft.com/office/drawing/2014/main" id="{C0BABC11-2229-4A68-B07E-5C2DD471CD8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1078" y="16042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Rectangle 7">
            <a:extLst>
              <a:ext uri="{FF2B5EF4-FFF2-40B4-BE49-F238E27FC236}">
                <a16:creationId xmlns:a16="http://schemas.microsoft.com/office/drawing/2014/main" id="{1F46B304-0ACF-45A7-8A6B-43019731A546}"/>
              </a:ext>
            </a:extLst>
          </p:cNvPr>
          <p:cNvSpPr/>
          <p:nvPr/>
        </p:nvSpPr>
        <p:spPr>
          <a:xfrm>
            <a:off x="1085718" y="94939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045164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8">
            <a:extLst>
              <a:ext uri="{FF2B5EF4-FFF2-40B4-BE49-F238E27FC236}">
                <a16:creationId xmlns:a16="http://schemas.microsoft.com/office/drawing/2014/main" id="{41DDFC6C-34D6-4485-BD11-1BC163B0A135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2" descr="Resultado de imagen para iquibicen conicet">
            <a:extLst>
              <a:ext uri="{FF2B5EF4-FFF2-40B4-BE49-F238E27FC236}">
                <a16:creationId xmlns:a16="http://schemas.microsoft.com/office/drawing/2014/main" id="{36CDA46E-2AF6-4964-BF90-4B5AFC2091F9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Resultado de imagen para quimica biologica uba logo">
            <a:extLst>
              <a:ext uri="{FF2B5EF4-FFF2-40B4-BE49-F238E27FC236}">
                <a16:creationId xmlns:a16="http://schemas.microsoft.com/office/drawing/2014/main" id="{BBA010F4-B8C7-4EAB-9F10-57EEFF8B59F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Rectangle 7">
            <a:extLst>
              <a:ext uri="{FF2B5EF4-FFF2-40B4-BE49-F238E27FC236}">
                <a16:creationId xmlns:a16="http://schemas.microsoft.com/office/drawing/2014/main" id="{EF4D3DAE-E71E-45F1-A79C-B086805EC550}"/>
              </a:ext>
            </a:extLst>
          </p:cNvPr>
          <p:cNvSpPr/>
          <p:nvPr/>
        </p:nvSpPr>
        <p:spPr>
          <a:xfrm>
            <a:off x="1093739" y="7244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6" name="Imagen 5">
            <a:extLst>
              <a:ext uri="{FF2B5EF4-FFF2-40B4-BE49-F238E27FC236}">
                <a16:creationId xmlns:a16="http://schemas.microsoft.com/office/drawing/2014/main" id="{DBF0D293-58C9-45AC-8DB0-F9DE52C9E8D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24565" y="1186540"/>
            <a:ext cx="9773927" cy="46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340475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8">
            <a:extLst>
              <a:ext uri="{FF2B5EF4-FFF2-40B4-BE49-F238E27FC236}">
                <a16:creationId xmlns:a16="http://schemas.microsoft.com/office/drawing/2014/main" id="{8ACFCF68-E3E6-4686-AFDB-3AD7D923FF85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" name="Picture 2" descr="Resultado de imagen para iquibicen conicet">
            <a:extLst>
              <a:ext uri="{FF2B5EF4-FFF2-40B4-BE49-F238E27FC236}">
                <a16:creationId xmlns:a16="http://schemas.microsoft.com/office/drawing/2014/main" id="{F0A89B83-26A9-4F08-BA69-EE80EEC0A90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4" descr="Resultado de imagen para quimica biologica uba logo">
            <a:extLst>
              <a:ext uri="{FF2B5EF4-FFF2-40B4-BE49-F238E27FC236}">
                <a16:creationId xmlns:a16="http://schemas.microsoft.com/office/drawing/2014/main" id="{6C4AB659-F60C-4C52-8834-58615C9F37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3" name="Rectangle 7">
            <a:extLst>
              <a:ext uri="{FF2B5EF4-FFF2-40B4-BE49-F238E27FC236}">
                <a16:creationId xmlns:a16="http://schemas.microsoft.com/office/drawing/2014/main" id="{95AE5909-FD99-4FDA-9D02-09F39C808B3A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855B9607-3D57-4F1C-A1A6-666F74E8CFF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3677" y="1173345"/>
            <a:ext cx="9899239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8547311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Rectangle 8">
            <a:extLst>
              <a:ext uri="{FF2B5EF4-FFF2-40B4-BE49-F238E27FC236}">
                <a16:creationId xmlns:a16="http://schemas.microsoft.com/office/drawing/2014/main" id="{B39A02DE-9AAD-490D-9BDF-4AD233E38E2C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5" name="Picture 2" descr="Resultado de imagen para iquibicen conicet">
            <a:extLst>
              <a:ext uri="{FF2B5EF4-FFF2-40B4-BE49-F238E27FC236}">
                <a16:creationId xmlns:a16="http://schemas.microsoft.com/office/drawing/2014/main" id="{F19DA6EA-8C61-4732-A936-8AA916A1B6D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6" name="Picture 4" descr="Resultado de imagen para quimica biologica uba logo">
            <a:extLst>
              <a:ext uri="{FF2B5EF4-FFF2-40B4-BE49-F238E27FC236}">
                <a16:creationId xmlns:a16="http://schemas.microsoft.com/office/drawing/2014/main" id="{6D14D3EA-862D-4B99-97FD-83737793BED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7" name="Rectangle 7">
            <a:extLst>
              <a:ext uri="{FF2B5EF4-FFF2-40B4-BE49-F238E27FC236}">
                <a16:creationId xmlns:a16="http://schemas.microsoft.com/office/drawing/2014/main" id="{0D8E690A-E2B3-4A22-A2C8-54E17D42D610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1C189AB-A3D6-4AE1-88ED-F4BB527B708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6537" y="1160095"/>
            <a:ext cx="9855163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576194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8">
            <a:extLst>
              <a:ext uri="{FF2B5EF4-FFF2-40B4-BE49-F238E27FC236}">
                <a16:creationId xmlns:a16="http://schemas.microsoft.com/office/drawing/2014/main" id="{9B789C98-9B66-4B25-9ED5-AA5D701B8D33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2" descr="Resultado de imagen para iquibicen conicet">
            <a:extLst>
              <a:ext uri="{FF2B5EF4-FFF2-40B4-BE49-F238E27FC236}">
                <a16:creationId xmlns:a16="http://schemas.microsoft.com/office/drawing/2014/main" id="{E432960A-DE99-4430-9367-5F2CE47030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Resultado de imagen para quimica biologica uba logo">
            <a:extLst>
              <a:ext uri="{FF2B5EF4-FFF2-40B4-BE49-F238E27FC236}">
                <a16:creationId xmlns:a16="http://schemas.microsoft.com/office/drawing/2014/main" id="{54E6BAF8-8D30-41CE-9BD8-931A81FA0F0C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Rectangle 7">
            <a:extLst>
              <a:ext uri="{FF2B5EF4-FFF2-40B4-BE49-F238E27FC236}">
                <a16:creationId xmlns:a16="http://schemas.microsoft.com/office/drawing/2014/main" id="{B00BAD35-E327-4631-BFED-C29152373C27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1FD5796C-6B22-4027-84EA-ED273355FFB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98030" y="1183248"/>
            <a:ext cx="9811290" cy="50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4032847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8">
            <a:extLst>
              <a:ext uri="{FF2B5EF4-FFF2-40B4-BE49-F238E27FC236}">
                <a16:creationId xmlns:a16="http://schemas.microsoft.com/office/drawing/2014/main" id="{65120DAE-9628-4796-85C7-368199A32B1A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21" name="Picture 2" descr="Resultado de imagen para iquibicen conicet">
            <a:extLst>
              <a:ext uri="{FF2B5EF4-FFF2-40B4-BE49-F238E27FC236}">
                <a16:creationId xmlns:a16="http://schemas.microsoft.com/office/drawing/2014/main" id="{5965DF9C-BAF7-4DF6-B4CD-A2E95433937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2" name="Picture 4" descr="Resultado de imagen para quimica biologica uba logo">
            <a:extLst>
              <a:ext uri="{FF2B5EF4-FFF2-40B4-BE49-F238E27FC236}">
                <a16:creationId xmlns:a16="http://schemas.microsoft.com/office/drawing/2014/main" id="{B9762219-D926-4A40-BFB8-836A8D16D9C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3" name="Rectangle 7">
            <a:extLst>
              <a:ext uri="{FF2B5EF4-FFF2-40B4-BE49-F238E27FC236}">
                <a16:creationId xmlns:a16="http://schemas.microsoft.com/office/drawing/2014/main" id="{02DB11EB-8002-4884-B818-630FDAC0F994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74C08120-E9FB-40B0-B46F-E7CB56C5FF3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3008" y="1184310"/>
            <a:ext cx="9910818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052121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ctangle 8">
            <a:extLst>
              <a:ext uri="{FF2B5EF4-FFF2-40B4-BE49-F238E27FC236}">
                <a16:creationId xmlns:a16="http://schemas.microsoft.com/office/drawing/2014/main" id="{D959AF93-D590-467D-B50C-B7A8DCAD1416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2" name="Picture 2" descr="Resultado de imagen para iquibicen conicet">
            <a:extLst>
              <a:ext uri="{FF2B5EF4-FFF2-40B4-BE49-F238E27FC236}">
                <a16:creationId xmlns:a16="http://schemas.microsoft.com/office/drawing/2014/main" id="{C2FFE272-BB5B-4705-96B5-53E5F1A2C5C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4" descr="Resultado de imagen para quimica biologica uba logo">
            <a:extLst>
              <a:ext uri="{FF2B5EF4-FFF2-40B4-BE49-F238E27FC236}">
                <a16:creationId xmlns:a16="http://schemas.microsoft.com/office/drawing/2014/main" id="{5135BA46-64DA-45D0-A491-CEE0BE79361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4" name="Rectangle 7">
            <a:extLst>
              <a:ext uri="{FF2B5EF4-FFF2-40B4-BE49-F238E27FC236}">
                <a16:creationId xmlns:a16="http://schemas.microsoft.com/office/drawing/2014/main" id="{B9352CB2-5F54-4C3D-A968-BD672A15D2D5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4" name="Imagen 3">
            <a:extLst>
              <a:ext uri="{FF2B5EF4-FFF2-40B4-BE49-F238E27FC236}">
                <a16:creationId xmlns:a16="http://schemas.microsoft.com/office/drawing/2014/main" id="{8A9A9856-0296-4537-BC74-EA3EB19390D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7785" y="1212343"/>
            <a:ext cx="9913871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942616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Rectangle 8">
            <a:extLst>
              <a:ext uri="{FF2B5EF4-FFF2-40B4-BE49-F238E27FC236}">
                <a16:creationId xmlns:a16="http://schemas.microsoft.com/office/drawing/2014/main" id="{DA60F6DF-39EB-4581-9256-C8F107F3420A}"/>
              </a:ext>
            </a:extLst>
          </p:cNvPr>
          <p:cNvSpPr/>
          <p:nvPr/>
        </p:nvSpPr>
        <p:spPr>
          <a:xfrm>
            <a:off x="62647" y="6605554"/>
            <a:ext cx="12096000" cy="180000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8" name="Picture 2" descr="Resultado de imagen para iquibicen conicet">
            <a:extLst>
              <a:ext uri="{FF2B5EF4-FFF2-40B4-BE49-F238E27FC236}">
                <a16:creationId xmlns:a16="http://schemas.microsoft.com/office/drawing/2014/main" id="{3B961CE5-80B8-4017-B87D-518AC7CF3B6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126" y="15173"/>
            <a:ext cx="886854" cy="86732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9" name="Picture 4" descr="Resultado de imagen para quimica biologica uba logo">
            <a:extLst>
              <a:ext uri="{FF2B5EF4-FFF2-40B4-BE49-F238E27FC236}">
                <a16:creationId xmlns:a16="http://schemas.microsoft.com/office/drawing/2014/main" id="{49273EF3-4078-4AC2-8603-AAC192DBF2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319099" y="-6451"/>
            <a:ext cx="849817" cy="88458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20" name="Rectangle 7">
            <a:extLst>
              <a:ext uri="{FF2B5EF4-FFF2-40B4-BE49-F238E27FC236}">
                <a16:creationId xmlns:a16="http://schemas.microsoft.com/office/drawing/2014/main" id="{67D138B8-ED4E-45EC-978D-AD9C723776A2}"/>
              </a:ext>
            </a:extLst>
          </p:cNvPr>
          <p:cNvSpPr/>
          <p:nvPr/>
        </p:nvSpPr>
        <p:spPr>
          <a:xfrm>
            <a:off x="1093739" y="66916"/>
            <a:ext cx="10152000" cy="547523"/>
          </a:xfrm>
          <a:prstGeom prst="rect">
            <a:avLst/>
          </a:prstGeom>
          <a:solidFill>
            <a:srgbClr val="4472C4">
              <a:alpha val="30196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Imagen 2">
            <a:extLst>
              <a:ext uri="{FF2B5EF4-FFF2-40B4-BE49-F238E27FC236}">
                <a16:creationId xmlns:a16="http://schemas.microsoft.com/office/drawing/2014/main" id="{11D08ED2-1433-4292-8E26-BA673793223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62711" y="1160094"/>
            <a:ext cx="9894831" cy="486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9179871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6</TotalTime>
  <Words>44</Words>
  <Application>Microsoft Office PowerPoint</Application>
  <PresentationFormat>Panorámica</PresentationFormat>
  <Paragraphs>10</Paragraphs>
  <Slides>12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2</vt:i4>
      </vt:variant>
    </vt:vector>
  </HeadingPairs>
  <TitlesOfParts>
    <vt:vector size="16" baseType="lpstr">
      <vt:lpstr>Arial</vt:lpstr>
      <vt:lpstr>Calibri</vt:lpstr>
      <vt:lpstr>Calibri Light</vt:lpstr>
      <vt:lpstr>Tema de Office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LUMI</dc:creator>
  <cp:lastModifiedBy>LUMI</cp:lastModifiedBy>
  <cp:revision>53</cp:revision>
  <dcterms:created xsi:type="dcterms:W3CDTF">2021-10-13T16:02:59Z</dcterms:created>
  <dcterms:modified xsi:type="dcterms:W3CDTF">2021-11-24T21:39:21Z</dcterms:modified>
</cp:coreProperties>
</file>